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7" d="100"/>
          <a:sy n="77" d="100"/>
        </p:scale>
        <p:origin x="228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B99BBA-F66C-3A7F-DF7C-5E9AAE208A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A94A734-EAFA-F40E-3C5B-CEE1F7E8D8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454D39E-5FD9-EDFA-642A-AC4767E0E6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F62D20-FEBC-7650-F2F1-EB37E66C9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DAD5CB-B0FC-D68A-E064-D43B1119E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8061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1CCFADC-4BAA-2A11-F2B8-C499610F53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27AA076-18DD-2AB9-74C8-A6DAA615A2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656CA4-F1F7-B741-2047-2FE1E39EE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D6D92C-6FBB-AFCD-296C-792B1F579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F5CBABA-6A1F-ED42-A1D7-9CC0AAABF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9694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547E82B-B32F-1847-202F-CC0C380488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54DD22F-AB8F-A598-608A-385869536F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1D7B3A-8AA2-4C2A-7F88-0CF042E62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CFE567-6F0F-3B21-720E-E59B07400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4DAF4D-79F3-586F-1285-8DBA0ED5A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907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72BF10-A8AC-DCBB-F2EB-77F2788D80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F534A27-BAA8-151D-2C4C-0F4B81718D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960D6A7-8DA4-F889-706F-1A21AE060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7BFCCA3-7144-1199-C4AA-11DEA71B0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ABCFB6E-0A11-69B7-43EE-C613B7E8C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7012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ADEFA5-2FFB-E28C-D926-CBB9DAB5AB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017F51D-A192-750B-589B-0E3CF3F3DA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0989F0-E4DE-50E7-B67E-EE55568F0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BB5CAF-02A9-1C7C-3CA7-559A5C4E7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C8439A-051D-0D2C-D474-5F66DAFFEB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1179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02019A-C7FE-5D04-0097-D259BCF011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63BAFB-D4A4-518D-3FBF-E2778904BE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0C8B25A-7C16-D577-B50C-2AB721A199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14910A0-0A11-3ADB-BE23-A51D19849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7E83E8D-81D6-3D07-369E-E39D0F197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4CA8F31-E622-B275-5D7D-E508EBBD5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3993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5162BD-54D6-CEC7-54E0-C65E455B38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F4F4B8E-F0EE-9105-BA81-27FA9A983C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3626CF1-2BA6-69E5-6232-A61126FA81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4C4F28B-E479-E95B-897B-498CDDB497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69E51C5-4B58-C917-C823-A2A93F662C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5FD3667-F1B6-3FBB-F468-101D6BB5C9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7517A7F-9ADF-3C3C-7B1C-D25E6D99C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B1CAF5A-F45E-8C2F-999F-44C84E0BBA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0644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44B2D8-7BBE-2530-B591-2812C66588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73CCA22-88EF-9664-9270-ED8089454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6440288-BC1F-C6D9-CAD8-1F056780B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464DD4F-BF6E-D3A3-8F4B-BC40FE4F88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3841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B26F9D7-7DC9-2780-4143-C6E60C31F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56618FE-C544-8862-47E1-C3E201856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A723500-075D-BDE3-9078-99DEB5154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5150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FEDDF7-C77A-87EA-E6E9-137E66511E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C4F07BA-61B8-8492-FF59-60F4D35897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C96DDC9-2FAF-E9F9-A3F4-54A34008ED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1A1A850-D7E8-BD5C-F72C-96D2F578E9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389C11A-23F3-70EA-9A9B-240D5F04A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3830C65-0B4A-2520-7BF7-2FFED9B51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357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9FC41F-07CF-B811-F1CB-70FE7F7DB0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0B683D1-EB9C-16F1-E3E2-DA30F9036A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B6E5B23-0CF7-AE47-04F2-65ACF010BA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5CB939D-8257-8975-F765-A1976DA79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2EE8946-9D68-D04B-D985-672279D08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472DEC4-282B-B7A5-BB95-F8EE7DE09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6378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1BC8495-EAC9-EDB4-E310-F641E9957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4B2D5C0-1C44-20B8-415C-1073CC50DA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F1D2E5-1E9B-33DF-F1D6-5955607E30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CEF5F90-DADB-167E-C176-EA916160B5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7F82DA-2A06-7A92-5AAE-EE96E69893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4607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文本框 59">
            <a:extLst>
              <a:ext uri="{FF2B5EF4-FFF2-40B4-BE49-F238E27FC236}">
                <a16:creationId xmlns:a16="http://schemas.microsoft.com/office/drawing/2014/main" id="{015D3B56-3834-9D4E-CF9E-F3AEA54E6B00}"/>
              </a:ext>
            </a:extLst>
          </p:cNvPr>
          <p:cNvSpPr txBox="1"/>
          <p:nvPr/>
        </p:nvSpPr>
        <p:spPr>
          <a:xfrm>
            <a:off x="2263066" y="4694943"/>
            <a:ext cx="800821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dditional Figure 3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imulated extinction, absorption and scattering cross-sections of (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)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NS and (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)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NB.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7348A1C-46AE-F668-915A-2531661084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1852" y="503853"/>
            <a:ext cx="9330638" cy="3683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1705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22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瑞 张</dc:creator>
  <cp:lastModifiedBy>瑞 张</cp:lastModifiedBy>
  <cp:revision>4</cp:revision>
  <dcterms:created xsi:type="dcterms:W3CDTF">2023-11-27T11:36:49Z</dcterms:created>
  <dcterms:modified xsi:type="dcterms:W3CDTF">2024-02-07T14:10:59Z</dcterms:modified>
</cp:coreProperties>
</file>